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014" autoAdjust="0"/>
    <p:restoredTop sz="94660"/>
  </p:normalViewPr>
  <p:slideViewPr>
    <p:cSldViewPr snapToGrid="0">
      <p:cViewPr varScale="1">
        <p:scale>
          <a:sx n="88" d="100"/>
          <a:sy n="88" d="100"/>
        </p:scale>
        <p:origin x="1616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B60C3B-7C8F-4D98-8BCF-7930283A29B0}" type="datetimeFigureOut">
              <a:rPr lang="en-US" smtClean="0"/>
              <a:t>12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0732E-617F-46CA-9356-859D8D2BB44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74407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B60C3B-7C8F-4D98-8BCF-7930283A29B0}" type="datetimeFigureOut">
              <a:rPr lang="en-US" smtClean="0"/>
              <a:t>12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0732E-617F-46CA-9356-859D8D2BB44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89106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B60C3B-7C8F-4D98-8BCF-7930283A29B0}" type="datetimeFigureOut">
              <a:rPr lang="en-US" smtClean="0"/>
              <a:t>12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0732E-617F-46CA-9356-859D8D2BB44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119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B60C3B-7C8F-4D98-8BCF-7930283A29B0}" type="datetimeFigureOut">
              <a:rPr lang="en-US" smtClean="0"/>
              <a:t>12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0732E-617F-46CA-9356-859D8D2BB44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15351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B60C3B-7C8F-4D98-8BCF-7930283A29B0}" type="datetimeFigureOut">
              <a:rPr lang="en-US" smtClean="0"/>
              <a:t>12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0732E-617F-46CA-9356-859D8D2BB44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7015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B60C3B-7C8F-4D98-8BCF-7930283A29B0}" type="datetimeFigureOut">
              <a:rPr lang="en-US" smtClean="0"/>
              <a:t>12/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0732E-617F-46CA-9356-859D8D2BB44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30395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B60C3B-7C8F-4D98-8BCF-7930283A29B0}" type="datetimeFigureOut">
              <a:rPr lang="en-US" smtClean="0"/>
              <a:t>12/7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0732E-617F-46CA-9356-859D8D2BB44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63970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B60C3B-7C8F-4D98-8BCF-7930283A29B0}" type="datetimeFigureOut">
              <a:rPr lang="en-US" smtClean="0"/>
              <a:t>12/7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0732E-617F-46CA-9356-859D8D2BB44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62674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B60C3B-7C8F-4D98-8BCF-7930283A29B0}" type="datetimeFigureOut">
              <a:rPr lang="en-US" smtClean="0"/>
              <a:t>12/7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0732E-617F-46CA-9356-859D8D2BB44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55389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B60C3B-7C8F-4D98-8BCF-7930283A29B0}" type="datetimeFigureOut">
              <a:rPr lang="en-US" smtClean="0"/>
              <a:t>12/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0732E-617F-46CA-9356-859D8D2BB44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02582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B60C3B-7C8F-4D98-8BCF-7930283A29B0}" type="datetimeFigureOut">
              <a:rPr lang="en-US" smtClean="0"/>
              <a:t>12/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0732E-617F-46CA-9356-859D8D2BB44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39449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B60C3B-7C8F-4D98-8BCF-7930283A29B0}" type="datetimeFigureOut">
              <a:rPr lang="en-US" smtClean="0"/>
              <a:t>12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B0732E-617F-46CA-9356-859D8D2BB44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26757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54423B9F-1CF5-3B2E-6C22-7FD3F2E206A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6652" y="492044"/>
            <a:ext cx="4082143" cy="2286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44588C3-CE77-EF58-66F4-9B5D700A7E9D}"/>
              </a:ext>
            </a:extLst>
          </p:cNvPr>
          <p:cNvSpPr txBox="1"/>
          <p:nvPr/>
        </p:nvSpPr>
        <p:spPr>
          <a:xfrm>
            <a:off x="319790" y="198600"/>
            <a:ext cx="150291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/>
              <a:t>Ankazomiriotra </a:t>
            </a:r>
            <a:endParaRPr lang="en-US" sz="16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F197CFB-0825-9C21-BB8E-0BFBF0589FE8}"/>
              </a:ext>
            </a:extLst>
          </p:cNvPr>
          <p:cNvSpPr txBox="1"/>
          <p:nvPr/>
        </p:nvSpPr>
        <p:spPr>
          <a:xfrm>
            <a:off x="4478795" y="170267"/>
            <a:ext cx="68467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Anjiro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D7FA52AC-85BB-F879-179A-2093BBEA982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36461" y="497652"/>
            <a:ext cx="4082143" cy="22860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DFF11AF4-E1F4-0187-154B-273C92547ED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7054" y="3138360"/>
            <a:ext cx="4082143" cy="22860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3EACD71A-B7F6-AA41-D4C8-B57D9D16754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36461" y="3138360"/>
            <a:ext cx="4082143" cy="228600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92391E8A-9F71-3358-A6E3-C3AA3D865877}"/>
              </a:ext>
            </a:extLst>
          </p:cNvPr>
          <p:cNvSpPr txBox="1"/>
          <p:nvPr/>
        </p:nvSpPr>
        <p:spPr>
          <a:xfrm>
            <a:off x="4478795" y="2852725"/>
            <a:ext cx="1495647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dirty="0" err="1"/>
              <a:t>Marovoay</a:t>
            </a:r>
            <a:endParaRPr lang="en-US" sz="16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43C57A9-1986-3353-841A-0DC7301EA492}"/>
              </a:ext>
            </a:extLst>
          </p:cNvPr>
          <p:cNvSpPr txBox="1"/>
          <p:nvPr/>
        </p:nvSpPr>
        <p:spPr>
          <a:xfrm>
            <a:off x="319790" y="2848786"/>
            <a:ext cx="85953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Behenjy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1CF9737-DB4E-6890-E3AA-0DBFDEA0EC7C}"/>
              </a:ext>
            </a:extLst>
          </p:cNvPr>
          <p:cNvSpPr txBox="1"/>
          <p:nvPr/>
        </p:nvSpPr>
        <p:spPr>
          <a:xfrm>
            <a:off x="91003" y="5531244"/>
            <a:ext cx="573353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ry </a:t>
            </a:r>
            <a:r>
              <a:rPr lang="en-US" sz="1200" b="1"/>
              <a:t>Figure S1</a:t>
            </a:r>
            <a:r>
              <a:rPr lang="en-US" sz="1200"/>
              <a:t>: </a:t>
            </a:r>
            <a:r>
              <a:rPr lang="en-US" sz="1200" dirty="0"/>
              <a:t>Results of hedonic test conducted at 4 villages with 100 participants each. Rice was prepared locally by villagers and their impression on appearance, taste and texture recorded by FOFIFA staff. MTM 32 and HY-85-2 correspond to FyVary32 and 85, respectively. While slight differences in preference existed between villages, with FyVary32 being preferred in Anjiro compared to FyVary85 in </a:t>
            </a:r>
            <a:r>
              <a:rPr lang="en-US" sz="1200" dirty="0" err="1"/>
              <a:t>Marovoay</a:t>
            </a:r>
            <a:r>
              <a:rPr lang="en-US" sz="1200" dirty="0"/>
              <a:t>, overall rankings of both varieties </a:t>
            </a:r>
            <a:r>
              <a:rPr lang="en-US" sz="1200"/>
              <a:t>were not significantly </a:t>
            </a:r>
            <a:r>
              <a:rPr lang="en-US" sz="1200" dirty="0"/>
              <a:t>different from local variety X265. 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8C5538D7-9FC2-55AD-484B-17BC78D5A65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740352" y="5697681"/>
            <a:ext cx="3180840" cy="970512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D1131887-3983-C504-C170-00D12F2A188A}"/>
              </a:ext>
            </a:extLst>
          </p:cNvPr>
          <p:cNvSpPr txBox="1"/>
          <p:nvPr/>
        </p:nvSpPr>
        <p:spPr>
          <a:xfrm>
            <a:off x="5651543" y="5436908"/>
            <a:ext cx="1227051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dirty="0"/>
              <a:t>summary</a:t>
            </a:r>
          </a:p>
        </p:txBody>
      </p:sp>
    </p:spTree>
    <p:extLst>
      <p:ext uri="{BB962C8B-B14F-4D97-AF65-F5344CB8AC3E}">
        <p14:creationId xmlns:p14="http://schemas.microsoft.com/office/powerpoint/2010/main" val="23492113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0</TotalTime>
  <Words>89</Words>
  <Application>Microsoft Office PowerPoint</Application>
  <PresentationFormat>Bildschirmpräsentation 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tthias Wissuwa</dc:creator>
  <cp:lastModifiedBy>Matthias</cp:lastModifiedBy>
  <cp:revision>10</cp:revision>
  <dcterms:created xsi:type="dcterms:W3CDTF">2024-08-22T15:25:21Z</dcterms:created>
  <dcterms:modified xsi:type="dcterms:W3CDTF">2025-12-07T03:37:50Z</dcterms:modified>
</cp:coreProperties>
</file>